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7C80"/>
    <a:srgbClr val="FF66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7" d="100"/>
          <a:sy n="77" d="100"/>
        </p:scale>
        <p:origin x="304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E7AC6-0F06-48C0-A9BF-092DA258951F}" type="datetimeFigureOut">
              <a:rPr lang="en-GB" smtClean="0"/>
              <a:t>08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66E4-ED0F-48C5-8301-DDCE4AD50D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53295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E7AC6-0F06-48C0-A9BF-092DA258951F}" type="datetimeFigureOut">
              <a:rPr lang="en-GB" smtClean="0"/>
              <a:t>08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66E4-ED0F-48C5-8301-DDCE4AD50D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49896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E7AC6-0F06-48C0-A9BF-092DA258951F}" type="datetimeFigureOut">
              <a:rPr lang="en-GB" smtClean="0"/>
              <a:t>08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66E4-ED0F-48C5-8301-DDCE4AD50D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71499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E7AC6-0F06-48C0-A9BF-092DA258951F}" type="datetimeFigureOut">
              <a:rPr lang="en-GB" smtClean="0"/>
              <a:t>08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66E4-ED0F-48C5-8301-DDCE4AD50D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97199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E7AC6-0F06-48C0-A9BF-092DA258951F}" type="datetimeFigureOut">
              <a:rPr lang="en-GB" smtClean="0"/>
              <a:t>08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66E4-ED0F-48C5-8301-DDCE4AD50D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67049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E7AC6-0F06-48C0-A9BF-092DA258951F}" type="datetimeFigureOut">
              <a:rPr lang="en-GB" smtClean="0"/>
              <a:t>08/03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66E4-ED0F-48C5-8301-DDCE4AD50D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99737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E7AC6-0F06-48C0-A9BF-092DA258951F}" type="datetimeFigureOut">
              <a:rPr lang="en-GB" smtClean="0"/>
              <a:t>08/03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66E4-ED0F-48C5-8301-DDCE4AD50D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6172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E7AC6-0F06-48C0-A9BF-092DA258951F}" type="datetimeFigureOut">
              <a:rPr lang="en-GB" smtClean="0"/>
              <a:t>08/03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66E4-ED0F-48C5-8301-DDCE4AD50D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59862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E7AC6-0F06-48C0-A9BF-092DA258951F}" type="datetimeFigureOut">
              <a:rPr lang="en-GB" smtClean="0"/>
              <a:t>08/03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66E4-ED0F-48C5-8301-DDCE4AD50D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77129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E7AC6-0F06-48C0-A9BF-092DA258951F}" type="datetimeFigureOut">
              <a:rPr lang="en-GB" smtClean="0"/>
              <a:t>08/03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66E4-ED0F-48C5-8301-DDCE4AD50D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17305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E7AC6-0F06-48C0-A9BF-092DA258951F}" type="datetimeFigureOut">
              <a:rPr lang="en-GB" smtClean="0"/>
              <a:t>08/03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66E4-ED0F-48C5-8301-DDCE4AD50D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36434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1E7AC6-0F06-48C0-A9BF-092DA258951F}" type="datetimeFigureOut">
              <a:rPr lang="en-GB" smtClean="0"/>
              <a:t>08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DA66E4-ED0F-48C5-8301-DDCE4AD50D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99746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4">
            <a:extLst>
              <a:ext uri="{FF2B5EF4-FFF2-40B4-BE49-F238E27FC236}">
                <a16:creationId xmlns:a16="http://schemas.microsoft.com/office/drawing/2014/main" id="{B26BE463-9A85-29B8-1486-DDE12B8D522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1399" b="47611"/>
          <a:stretch/>
        </p:blipFill>
        <p:spPr>
          <a:xfrm>
            <a:off x="302522" y="601662"/>
            <a:ext cx="6035648" cy="227965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02B1EB0-110F-5985-E5F3-5CC5B3E8BBCC}"/>
              </a:ext>
            </a:extLst>
          </p:cNvPr>
          <p:cNvSpPr txBox="1"/>
          <p:nvPr/>
        </p:nvSpPr>
        <p:spPr>
          <a:xfrm>
            <a:off x="302522" y="3399251"/>
            <a:ext cx="6035648" cy="1513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</a:p>
          <a:p>
            <a:pPr>
              <a:lnSpc>
                <a:spcPct val="200000"/>
              </a:lnSpc>
            </a:pP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tial sequence chromatograms of six potential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dmc1-D1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ISPR mutants from the T</a:t>
            </a:r>
            <a:r>
              <a:rPr lang="en-GB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ration, showing position of a 39 bp homozygous deletion of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C1-D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wo of the mutants, DMC1_R1_A10 and DMC1_R1_C06. </a:t>
            </a:r>
          </a:p>
        </p:txBody>
      </p:sp>
      <p:sp>
        <p:nvSpPr>
          <p:cNvPr id="7" name="Right Brace 6">
            <a:extLst>
              <a:ext uri="{FF2B5EF4-FFF2-40B4-BE49-F238E27FC236}">
                <a16:creationId xmlns:a16="http://schemas.microsoft.com/office/drawing/2014/main" id="{BCB72ACA-1CF2-60D1-DC9B-DEA9C59E222A}"/>
              </a:ext>
            </a:extLst>
          </p:cNvPr>
          <p:cNvSpPr/>
          <p:nvPr/>
        </p:nvSpPr>
        <p:spPr>
          <a:xfrm rot="5400000">
            <a:off x="4767673" y="2272133"/>
            <a:ext cx="115858" cy="1302544"/>
          </a:xfrm>
          <a:prstGeom prst="rightBrace">
            <a:avLst/>
          </a:prstGeom>
          <a:ln w="12700">
            <a:solidFill>
              <a:schemeClr val="accent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03C72A4-C2B5-3B74-9277-F211BFCB972B}"/>
              </a:ext>
            </a:extLst>
          </p:cNvPr>
          <p:cNvSpPr txBox="1"/>
          <p:nvPr/>
        </p:nvSpPr>
        <p:spPr>
          <a:xfrm>
            <a:off x="4329113" y="2951772"/>
            <a:ext cx="10763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9 bp deletion 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84974549-FA45-1B09-D123-0E9D7B497AE7}"/>
              </a:ext>
            </a:extLst>
          </p:cNvPr>
          <p:cNvSpPr/>
          <p:nvPr/>
        </p:nvSpPr>
        <p:spPr>
          <a:xfrm>
            <a:off x="523875" y="2171700"/>
            <a:ext cx="433388" cy="128588"/>
          </a:xfrm>
          <a:prstGeom prst="rect">
            <a:avLst/>
          </a:prstGeom>
          <a:solidFill>
            <a:srgbClr val="FF7C80">
              <a:alpha val="26667"/>
            </a:srgbClr>
          </a:solidFill>
          <a:ln w="63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F0B70AD2-1C17-6686-8F12-E047ADB538D1}"/>
              </a:ext>
            </a:extLst>
          </p:cNvPr>
          <p:cNvSpPr/>
          <p:nvPr/>
        </p:nvSpPr>
        <p:spPr>
          <a:xfrm>
            <a:off x="523875" y="2470768"/>
            <a:ext cx="433388" cy="128588"/>
          </a:xfrm>
          <a:prstGeom prst="rect">
            <a:avLst/>
          </a:prstGeom>
          <a:solidFill>
            <a:srgbClr val="FF7C80">
              <a:alpha val="26667"/>
            </a:srgbClr>
          </a:solidFill>
          <a:ln w="63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21687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6</TotalTime>
  <Words>48</Words>
  <Application>Microsoft Office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acie Draeger (JIC)</dc:creator>
  <cp:lastModifiedBy>Tracie Draeger (JIC)</cp:lastModifiedBy>
  <cp:revision>5</cp:revision>
  <dcterms:created xsi:type="dcterms:W3CDTF">2023-03-08T14:49:56Z</dcterms:created>
  <dcterms:modified xsi:type="dcterms:W3CDTF">2023-03-08T17:47:49Z</dcterms:modified>
</cp:coreProperties>
</file>